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9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1F1F1"/>
    <a:srgbClr val="00F8F8"/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Light Style 1 -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352"/>
    <p:restoredTop sz="95794"/>
  </p:normalViewPr>
  <p:slideViewPr>
    <p:cSldViewPr snapToGrid="0" snapToObjects="1">
      <p:cViewPr varScale="1">
        <p:scale>
          <a:sx n="106" d="100"/>
          <a:sy n="106" d="100"/>
        </p:scale>
        <p:origin x="696" y="184"/>
      </p:cViewPr>
      <p:guideLst/>
    </p:cSldViewPr>
  </p:slideViewPr>
  <p:notesTextViewPr>
    <p:cViewPr>
      <p:scale>
        <a:sx n="105" d="100"/>
        <a:sy n="105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A6043E6-5288-1C4A-AE46-87E99E423894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F8160EB-670F-8345-B3A6-1794A808C03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01535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685800" y="1143000"/>
            <a:ext cx="548640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F8160EB-670F-8345-B3A6-1794A808C03F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98479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744AC4-F4EE-1D48-B741-38E5365DC9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C048E4B-7419-0846-8CE8-89F36B1079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59" indent="0" algn="ctr">
              <a:buNone/>
              <a:defRPr sz="2000"/>
            </a:lvl2pPr>
            <a:lvl3pPr marL="914317" indent="0" algn="ctr">
              <a:buNone/>
              <a:defRPr sz="1800"/>
            </a:lvl3pPr>
            <a:lvl4pPr marL="1371475" indent="0" algn="ctr">
              <a:buNone/>
              <a:defRPr sz="1600"/>
            </a:lvl4pPr>
            <a:lvl5pPr marL="1828633" indent="0" algn="ctr">
              <a:buNone/>
              <a:defRPr sz="1600"/>
            </a:lvl5pPr>
            <a:lvl6pPr marL="2285792" indent="0" algn="ctr">
              <a:buNone/>
              <a:defRPr sz="1600"/>
            </a:lvl6pPr>
            <a:lvl7pPr marL="2742950" indent="0" algn="ctr">
              <a:buNone/>
              <a:defRPr sz="1600"/>
            </a:lvl7pPr>
            <a:lvl8pPr marL="3200109" indent="0" algn="ctr">
              <a:buNone/>
              <a:defRPr sz="1600"/>
            </a:lvl8pPr>
            <a:lvl9pPr marL="365726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3D4DF2-B1E2-1642-BB26-F58A615265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1E6B35-4FD3-9546-8203-C9B4BCCC2C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6647D0-8EE6-A04A-A04A-548385D9DC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9990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D4E37BA-F3E2-B946-86B1-6D35A8DBD9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A9CCFF5-9DCB-0E4D-9D8D-FD23D7DCCCA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90A60D-9037-6347-AC84-13EE355B143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38C037-6238-9E46-B6F6-B6D11F751C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C285A0C-CEB4-B440-ADA4-360FD4A29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6354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5A0348A-D30F-9F4C-80DD-5FECEEF5596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899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69ACAF-8EC7-DA46-B534-98B0A04AAD2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199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46EC88-27D5-4E45-A8CC-B7E2E0AD3B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D66E07-85FD-1440-94EC-B529682EA2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0558C4-CA96-DA4E-A967-14DF4CBE8B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74177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B70DC9-E69E-5144-83CE-3A1023D9D8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D5B62D8-AF3E-0C43-BAB7-ACC72FE29B2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3FB05A-1E5E-9C41-9C9A-7D4E6DCEE5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87F709-90CF-5340-83B3-B426A9523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83E048-C1AB-4E4D-9345-304BF7D6C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268647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0C2B3E-83AE-C846-A2E0-F5CC43C94B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2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ADB7CF-0EAD-2C4D-A503-24CEAE97A86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2" y="4589464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159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17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47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63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792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295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109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26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707AB38-0EE9-BC4A-B1B0-E320509C80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D697E7-F1BC-4B43-8649-B015D9933B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37677E-5322-B446-92CD-FB96883664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45055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EB55CC-8881-3F46-991C-6D4772FD59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10FEE5-D3C1-B149-9CA2-B3CF048D7F7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1" y="1825626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6098F95-8E8F-394A-BBF0-A85AFA34B4D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1" y="1825626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BE87170-B37D-BC40-AF11-C389FAF452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F67C4A-7E1F-D14F-9A25-3CC053EF7A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27E756B-FCCB-5B47-83F2-8E48EBFF5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55283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19CCF7-600C-804A-84A2-CE71F7A36D2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9" y="365126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1A99785-E40A-F94C-8819-F5D9A468E7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9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9" indent="0">
              <a:buNone/>
              <a:defRPr sz="2000" b="1"/>
            </a:lvl2pPr>
            <a:lvl3pPr marL="914317" indent="0">
              <a:buNone/>
              <a:defRPr sz="1800" b="1"/>
            </a:lvl3pPr>
            <a:lvl4pPr marL="1371475" indent="0">
              <a:buNone/>
              <a:defRPr sz="1600" b="1"/>
            </a:lvl4pPr>
            <a:lvl5pPr marL="1828633" indent="0">
              <a:buNone/>
              <a:defRPr sz="1600" b="1"/>
            </a:lvl5pPr>
            <a:lvl6pPr marL="2285792" indent="0">
              <a:buNone/>
              <a:defRPr sz="1600" b="1"/>
            </a:lvl6pPr>
            <a:lvl7pPr marL="2742950" indent="0">
              <a:buNone/>
              <a:defRPr sz="1600" b="1"/>
            </a:lvl7pPr>
            <a:lvl8pPr marL="3200109" indent="0">
              <a:buNone/>
              <a:defRPr sz="1600" b="1"/>
            </a:lvl8pPr>
            <a:lvl9pPr marL="365726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E320B0-2F9F-7F41-A913-E8A30E31EB6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9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DF583F-6263-E949-A1ED-13A6409FC13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2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59" indent="0">
              <a:buNone/>
              <a:defRPr sz="2000" b="1"/>
            </a:lvl2pPr>
            <a:lvl3pPr marL="914317" indent="0">
              <a:buNone/>
              <a:defRPr sz="1800" b="1"/>
            </a:lvl3pPr>
            <a:lvl4pPr marL="1371475" indent="0">
              <a:buNone/>
              <a:defRPr sz="1600" b="1"/>
            </a:lvl4pPr>
            <a:lvl5pPr marL="1828633" indent="0">
              <a:buNone/>
              <a:defRPr sz="1600" b="1"/>
            </a:lvl5pPr>
            <a:lvl6pPr marL="2285792" indent="0">
              <a:buNone/>
              <a:defRPr sz="1600" b="1"/>
            </a:lvl6pPr>
            <a:lvl7pPr marL="2742950" indent="0">
              <a:buNone/>
              <a:defRPr sz="1600" b="1"/>
            </a:lvl7pPr>
            <a:lvl8pPr marL="3200109" indent="0">
              <a:buNone/>
              <a:defRPr sz="1600" b="1"/>
            </a:lvl8pPr>
            <a:lvl9pPr marL="3657267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A11D22-8267-4347-93BA-EB444C5238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2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2E2CD6F-8596-5E41-8C2A-5BB0129AF5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D734ADA-1212-944D-B678-BC7FBB4A16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CE11094-D6CC-944E-9620-5F382BF28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1114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272947-DC83-A845-9B52-2BBCCD4B4E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439217B5-5EB0-4042-9894-169DEB8B6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EF03C26-0CFD-C74D-BBD3-CC05F890F3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9A37C49-8EA1-5149-A2A1-639858B05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03701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560A0C3-5DD8-1440-94EC-FD58F656F8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AFED5B7-710D-3948-A136-463B3E73FF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D9A8AB0-4947-8D4D-B1D3-AD86B0A52F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97186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15AEBB-DB81-9F4F-8CE2-0E9FFA3230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36B17BE-9150-0B45-BEA2-435E64EA62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>
              <a:defRPr sz="3200"/>
            </a:lvl1pPr>
            <a:lvl2pPr>
              <a:defRPr sz="2799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0CA32BC-22A2-D34A-8C2B-998003E3A8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59" indent="0">
              <a:buNone/>
              <a:defRPr sz="1400"/>
            </a:lvl2pPr>
            <a:lvl3pPr marL="914317" indent="0">
              <a:buNone/>
              <a:defRPr sz="1200"/>
            </a:lvl3pPr>
            <a:lvl4pPr marL="1371475" indent="0">
              <a:buNone/>
              <a:defRPr sz="1000"/>
            </a:lvl4pPr>
            <a:lvl5pPr marL="1828633" indent="0">
              <a:buNone/>
              <a:defRPr sz="1000"/>
            </a:lvl5pPr>
            <a:lvl6pPr marL="2285792" indent="0">
              <a:buNone/>
              <a:defRPr sz="1000"/>
            </a:lvl6pPr>
            <a:lvl7pPr marL="2742950" indent="0">
              <a:buNone/>
              <a:defRPr sz="1000"/>
            </a:lvl7pPr>
            <a:lvl8pPr marL="3200109" indent="0">
              <a:buNone/>
              <a:defRPr sz="1000"/>
            </a:lvl8pPr>
            <a:lvl9pPr marL="3657267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F4ED1B9-4D65-6E4F-9235-85EFE1235F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6CB5C12-E24A-7C4F-BB70-6C027A23E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8FD416-D51C-444C-9181-DDF53856A3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9042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C336F4-2FC4-BF43-885C-70A5DDCCA3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90" y="457200"/>
            <a:ext cx="3932236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4B9E8A1-2767-C243-90FF-10BF90E4959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6"/>
            <a:ext cx="6172201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159" indent="0">
              <a:buNone/>
              <a:defRPr sz="2799"/>
            </a:lvl2pPr>
            <a:lvl3pPr marL="914317" indent="0">
              <a:buNone/>
              <a:defRPr sz="2400"/>
            </a:lvl3pPr>
            <a:lvl4pPr marL="1371475" indent="0">
              <a:buNone/>
              <a:defRPr sz="2000"/>
            </a:lvl4pPr>
            <a:lvl5pPr marL="1828633" indent="0">
              <a:buNone/>
              <a:defRPr sz="2000"/>
            </a:lvl5pPr>
            <a:lvl6pPr marL="2285792" indent="0">
              <a:buNone/>
              <a:defRPr sz="2000"/>
            </a:lvl6pPr>
            <a:lvl7pPr marL="2742950" indent="0">
              <a:buNone/>
              <a:defRPr sz="2000"/>
            </a:lvl7pPr>
            <a:lvl8pPr marL="3200109" indent="0">
              <a:buNone/>
              <a:defRPr sz="2000"/>
            </a:lvl8pPr>
            <a:lvl9pPr marL="3657267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49ABC7-A3F0-B744-9EB6-FD5E933E930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90" y="2057400"/>
            <a:ext cx="3932236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59" indent="0">
              <a:buNone/>
              <a:defRPr sz="1400"/>
            </a:lvl2pPr>
            <a:lvl3pPr marL="914317" indent="0">
              <a:buNone/>
              <a:defRPr sz="1200"/>
            </a:lvl3pPr>
            <a:lvl4pPr marL="1371475" indent="0">
              <a:buNone/>
              <a:defRPr sz="1000"/>
            </a:lvl4pPr>
            <a:lvl5pPr marL="1828633" indent="0">
              <a:buNone/>
              <a:defRPr sz="1000"/>
            </a:lvl5pPr>
            <a:lvl6pPr marL="2285792" indent="0">
              <a:buNone/>
              <a:defRPr sz="1000"/>
            </a:lvl6pPr>
            <a:lvl7pPr marL="2742950" indent="0">
              <a:buNone/>
              <a:defRPr sz="1000"/>
            </a:lvl7pPr>
            <a:lvl8pPr marL="3200109" indent="0">
              <a:buNone/>
              <a:defRPr sz="1000"/>
            </a:lvl8pPr>
            <a:lvl9pPr marL="3657267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24A8E1-5735-8F40-93D3-DCD3F6779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12EF681-6118-5D4E-B6C5-6F80B03F62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DE7514-D013-2544-B42C-154550847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38582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6DAF07A-5396-E142-9680-69B49FA8A4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2" y="365126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1A3D35D-179B-8943-A746-CD9C4A1D47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2" y="1825626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E7DD8D-41DC-7448-B6B6-A2F9CC7830E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92E15C-DF0D-094F-9F6D-A2D01378188B}" type="datetimeFigureOut">
              <a:rPr lang="en-US" smtClean="0"/>
              <a:t>10/27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61B3B90-C74D-A744-B6C6-FBB917305C8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2" y="6356351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B771DAA-C07E-534B-9752-B62B0D3346E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1" y="6356351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9533DEA-B953-8749-9147-022E1507ECA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87609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317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79" indent="-228579" algn="l" defTabSz="914317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799" kern="1200">
          <a:solidFill>
            <a:schemeClr val="tx1"/>
          </a:solidFill>
          <a:latin typeface="+mn-lt"/>
          <a:ea typeface="+mn-ea"/>
          <a:cs typeface="+mn-cs"/>
        </a:defRPr>
      </a:lvl1pPr>
      <a:lvl2pPr marL="685737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896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054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213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371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529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688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5846" indent="-228579" algn="l" defTabSz="914317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59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17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475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633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792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2950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109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267" algn="l" defTabSz="91431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A2184E75-3474-8143-BEE1-F71267A4FB0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15238751"/>
              </p:ext>
            </p:extLst>
          </p:nvPr>
        </p:nvGraphicFramePr>
        <p:xfrm>
          <a:off x="198123" y="120062"/>
          <a:ext cx="11795754" cy="6748745"/>
        </p:xfrm>
        <a:graphic>
          <a:graphicData uri="http://schemas.openxmlformats.org/drawingml/2006/table">
            <a:tbl>
              <a:tblPr/>
              <a:tblGrid>
                <a:gridCol w="668525">
                  <a:extLst>
                    <a:ext uri="{9D8B030D-6E8A-4147-A177-3AD203B41FA5}">
                      <a16:colId xmlns:a16="http://schemas.microsoft.com/office/drawing/2014/main" val="4154606449"/>
                    </a:ext>
                  </a:extLst>
                </a:gridCol>
                <a:gridCol w="668525">
                  <a:extLst>
                    <a:ext uri="{9D8B030D-6E8A-4147-A177-3AD203B41FA5}">
                      <a16:colId xmlns:a16="http://schemas.microsoft.com/office/drawing/2014/main" val="473968965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525913291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2361443189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1598276148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2915966149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3575632494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1592569887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2320239412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2636876908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3443726767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3017627667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2958687225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4026727787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943928674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2640711381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1516104328"/>
                    </a:ext>
                  </a:extLst>
                </a:gridCol>
                <a:gridCol w="653669">
                  <a:extLst>
                    <a:ext uri="{9D8B030D-6E8A-4147-A177-3AD203B41FA5}">
                      <a16:colId xmlns:a16="http://schemas.microsoft.com/office/drawing/2014/main" val="3297860667"/>
                    </a:ext>
                  </a:extLst>
                </a:gridCol>
              </a:tblGrid>
              <a:tr h="17888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 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eak Strain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Systolic Strain Rate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Early Diastolic Strain Rate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rtl="0" fontAlgn="ctr"/>
                      <a:r>
                        <a:rPr lang="en-US" sz="9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Late Diastolic Strain Rate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49607688"/>
                  </a:ext>
                </a:extLst>
              </a:tr>
              <a:tr h="178889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train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gion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</a:t>
                      </a:r>
                    </a:p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2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D CM</a:t>
                      </a:r>
                    </a:p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4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1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UC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</a:t>
                      </a:r>
                    </a:p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2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D CM</a:t>
                      </a:r>
                    </a:p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4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C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</a:t>
                      </a:r>
                    </a:p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2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D CM</a:t>
                      </a:r>
                    </a:p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4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C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trl</a:t>
                      </a:r>
                    </a:p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2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DMD CM</a:t>
                      </a:r>
                    </a:p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=4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1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p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AUC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33245477"/>
                  </a:ext>
                </a:extLst>
              </a:tr>
              <a:tr h="178889">
                <a:tc rowSpan="17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adial Strain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E</a:t>
                      </a:r>
                      <a:r>
                        <a:rPr lang="en-US" sz="10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r</a:t>
                      </a:r>
                      <a:r>
                        <a:rPr lang="en-US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9.6 ± 14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7 ± 19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BC89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6 ± 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9C18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4 ± 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 ± 1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FCA9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 ± 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 ± 1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DFC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91878277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 ± 19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4 ± 13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D4A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± 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D2A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 ± 1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E1C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 ± 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E5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8703205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.1 ± 16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9 ± 14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D2A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5 ± 1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 ± 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1A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 ± 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3E5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1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E8D3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6014021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1.2 ± 25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2 ± 19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D2A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 ± 1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5CC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5 ± 2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7DAB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 ± 2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7E7D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4112738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6.2 ± 2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 ± 2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5CC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9 ± 1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± 1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1CA9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1 ± 2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 ± 2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1A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 ± 2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 ± 1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7E7D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3714170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.7 ± 18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9 ± 2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2CB9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.1 ± 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 ± 1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5C68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.3 ± 2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3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5CC9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 ± 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 ± 1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E1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5212177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4.5 ± 17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 ± 17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BDCB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 ± 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1A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9 ± 1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 ± 1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5D9B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 ± 1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5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EDDB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61644068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8.7 ± 13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.5 ± 14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8DAB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6D9B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 ± 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DCB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1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 ± 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AE1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67637262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0.1 ± 13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8 ± 1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D3A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BCE9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1 ± 1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DCB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ADBB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68733482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.5 ± 16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.7 ± 19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D2A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5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EC99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8 ± 1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D8B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6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5E6C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9696562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6.2 ± 2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9 ± 17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D8B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4 ± 1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 ± 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1D7B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4 ± 2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DDB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 ± 1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0DDBD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41354931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9.4 ± 29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6 ± 16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B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 ± 1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1A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2 ± 2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 ± 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9DBB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 ± 1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E5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2491582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5.2 ± 16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.4 ± 12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1DEB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 ± 0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D8B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 ± 1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2 ± 1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BE9D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9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8E1C5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05073801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7 ± 14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.4 ± 1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0D7B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 ± 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D2A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8 ± 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9 ± 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7D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E1C6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59523212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2 ± 11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.6 ± 12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ACE9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 ± 0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2D1A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8 ± 1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0D7B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7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3 ± 1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2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1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2EB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83821517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9.7 ± 17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.7 ± 13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D8B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1 ± 1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DD6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 ± 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3 ± 1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E5CE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 ± 1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1 ± 0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ADBB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34394199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7 ± 2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 ± 2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FD0A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 ± 0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 ± 0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D0A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4 ± 0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 ± 0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4D9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0.2 ± 0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 ± 0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8D4A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0735575"/>
                  </a:ext>
                </a:extLst>
              </a:tr>
              <a:tr h="178889">
                <a:tc rowSpan="17"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Surface Area Strain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E</a:t>
                      </a:r>
                      <a:r>
                        <a:rPr lang="en-US" sz="1000" b="0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</a:t>
                      </a:r>
                      <a:r>
                        <a:rPr lang="en-US" sz="1000" b="0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)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3.1 ± 5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9.1 ± 6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FE4C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0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AC18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9D4A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BF5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23792685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8.1 ± 6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4.3 ± 6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2E5C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1CA9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2D8B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 ± 0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 ± 0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EA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44012081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8.6 ± 6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4.1 ± 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0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2DEC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4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ACE9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9E1C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 ± 0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4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6EDD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14910578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3.9 ± 5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.9 ± 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7D3A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5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7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4C58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8D4A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DDCB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28372486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3.4 ± 4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.3 ± 7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8D4A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5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2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3BE7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7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BD5A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CE2C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06147882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.5 ± 5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7.9 ± 7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8E7D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2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6CC9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8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4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4D9B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7FA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99421063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9.2 ± 6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9 ± 7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1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5F9F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D2A5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E2C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 ± 0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7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F3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8809573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7.1 ± 7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5.5 ± 7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8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0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CFC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9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7E7D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AE8D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 ± 0.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28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1F1E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54898546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1.2 ± 8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6.3 ± 7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7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DE3C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6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D2A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E5C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9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3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EEAD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06342919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5.4 ± 8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0.2 ± 8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BE2C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4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7FCA9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3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7DAB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2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1E4C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22830450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3.3 ± 6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9.6 ± 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5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9E8D3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8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4D2A6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9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8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7E7D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2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2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8F4E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54341185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0.5 ± 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9.2 ± 7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8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3F9F7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7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6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DD6AD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DCB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9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5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BF5F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79457747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6.6 ± 9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4.7 ± 1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43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7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2F2E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6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0E4CB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 ± 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3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EAD9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3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2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4F9F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2026225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3.7 ± 14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9.6 ± 1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7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9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FE2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 ± 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1.9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1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FDDBC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 ± 0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7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7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2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FEAD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1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3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4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DF6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11927140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2.9 ± 9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8 ± 1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6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4E6C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9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1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DCF9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6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 ± 1.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2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CDCBA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5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5F3E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52315854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0F0F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3.3 ± 8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9.8 ± 11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18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0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8EEE0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9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5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A1D8B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7 ± 0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 ± 0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3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5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6E6D1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 ± 0.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80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1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7FAF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8617652"/>
                  </a:ext>
                </a:extLst>
              </a:tr>
              <a:tr h="1788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9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5.5 ± 9.1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40.6 ± 9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4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4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AE8D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3.1 ± 0.6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4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0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79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D2A4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8 ± 0.9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3 ± 0.8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012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680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CE2C8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5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6 ± 0.7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384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.563</a:t>
                      </a: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F4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86199374"/>
                  </a:ext>
                </a:extLst>
              </a:tr>
              <a:tr h="178889">
                <a:tc gridSpan="18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Ctrl - healthy control; DMD CM - Duchenne muscular dystrophy-associated cardiomyopathy; AUC - area under the curve</a:t>
                      </a:r>
                      <a:r>
                        <a:rPr lang="en-US" sz="600" dirty="0">
                          <a:effectLst/>
                        </a:rPr>
                        <a:t> </a:t>
                      </a:r>
                      <a:endParaRPr lang="en-US" sz="6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CAE8D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93D2A4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CE2C8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941" marR="3941" marT="3941" marB="0" anchor="ctr">
                    <a:lnL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E6F4E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3584348"/>
                  </a:ext>
                </a:extLst>
              </a:tr>
            </a:tbl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B6041CAC-0833-933A-3BF8-C9F876ACF147}"/>
              </a:ext>
            </a:extLst>
          </p:cNvPr>
          <p:cNvSpPr txBox="1"/>
          <p:nvPr/>
        </p:nvSpPr>
        <p:spPr>
          <a:xfrm>
            <a:off x="0" y="-97407"/>
            <a:ext cx="11063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/>
              <a:t>Additional File 6</a:t>
            </a:r>
          </a:p>
        </p:txBody>
      </p:sp>
    </p:spTree>
    <p:extLst>
      <p:ext uri="{BB962C8B-B14F-4D97-AF65-F5344CB8AC3E}">
        <p14:creationId xmlns:p14="http://schemas.microsoft.com/office/powerpoint/2010/main" val="10720557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391</TotalTime>
  <Words>1352</Words>
  <Application>Microsoft Macintosh PowerPoint</Application>
  <PresentationFormat>Widescreen</PresentationFormat>
  <Paragraphs>61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onner Earl</dc:creator>
  <cp:lastModifiedBy>Conner Earl</cp:lastModifiedBy>
  <cp:revision>62</cp:revision>
  <cp:lastPrinted>2022-02-06T03:55:09Z</cp:lastPrinted>
  <dcterms:created xsi:type="dcterms:W3CDTF">2022-01-21T23:01:07Z</dcterms:created>
  <dcterms:modified xsi:type="dcterms:W3CDTF">2022-10-27T13:48:08Z</dcterms:modified>
</cp:coreProperties>
</file>